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BE1D50-3418-42B5-B373-C4EDEFC26E2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F5A28C-DB3A-4496-946B-98D655FC42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80DA44-12DA-4C23-960B-DB24DAB86B1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815637-E386-49A0-AB55-A74E16299ED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5EC281-0C42-4D05-9821-1381F0CEAF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331DC9-703D-47C6-8402-62E59EDE60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884C58-CA1B-41D6-9DFE-25ED79EEBA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7352B1-6B54-47A9-84FE-CBED6B373A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03C742-CB88-4C10-932D-C00687929E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561BA6-DE37-4122-93CD-6154EFDEDC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B92FA1-E7F7-4EA6-811D-7A2FAE7B33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937FBA-35AB-4E37-9FEB-6638EB8421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8DCF46E-C2EB-4CDC-9990-88BAEEF8533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4"/>
          <p:cNvGrpSpPr/>
          <p:nvPr/>
        </p:nvGrpSpPr>
        <p:grpSpPr>
          <a:xfrm>
            <a:off x="2205000" y="1301760"/>
            <a:ext cx="2232000" cy="1670040"/>
            <a:chOff x="2205000" y="1301760"/>
            <a:chExt cx="2232000" cy="1670040"/>
          </a:xfrm>
        </p:grpSpPr>
        <p:pic>
          <p:nvPicPr>
            <p:cNvPr id="42" name="图片 8" descr=""/>
            <p:cNvPicPr/>
            <p:nvPr/>
          </p:nvPicPr>
          <p:blipFill>
            <a:blip r:embed="rId1"/>
            <a:srcRect l="0" t="15852" r="0" b="0"/>
            <a:stretch/>
          </p:blipFill>
          <p:spPr>
            <a:xfrm>
              <a:off x="2205000" y="1332000"/>
              <a:ext cx="2232000" cy="1639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文本框 9"/>
            <p:cNvSpPr/>
            <p:nvPr/>
          </p:nvSpPr>
          <p:spPr>
            <a:xfrm>
              <a:off x="2220840" y="1314360"/>
              <a:ext cx="650880" cy="450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3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微软雅黑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文本框 7"/>
            <p:cNvSpPr/>
            <p:nvPr/>
          </p:nvSpPr>
          <p:spPr>
            <a:xfrm>
              <a:off x="2922480" y="1301760"/>
              <a:ext cx="650880" cy="450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3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微软雅黑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文本框 5"/>
            <p:cNvSpPr/>
            <p:nvPr/>
          </p:nvSpPr>
          <p:spPr>
            <a:xfrm>
              <a:off x="3645000" y="1301760"/>
              <a:ext cx="652320" cy="450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3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微软雅黑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6" name="Rectangle 13"/>
          <p:cNvSpPr/>
          <p:nvPr/>
        </p:nvSpPr>
        <p:spPr>
          <a:xfrm>
            <a:off x="1341360" y="3274920"/>
            <a:ext cx="46087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FIG S1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Antioxidant activity of fraction 2 by DPPH method. (A) DPPH alcohol solution. (B) Fraction 2 solution. (C) Vc solution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23T12:20:13Z</dcterms:created>
  <dc:creator>微软用户</dc:creator>
  <dc:description/>
  <dc:language>en-US</dc:language>
  <cp:lastModifiedBy>刘士平</cp:lastModifiedBy>
  <dcterms:modified xsi:type="dcterms:W3CDTF">2017-11-09T07:42:51Z</dcterms:modified>
  <cp:revision>206</cp:revision>
  <dc:subject/>
  <dc:title>幻灯片 1</dc:title>
</cp:coreProperties>
</file>